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>
        <p:scale>
          <a:sx n="87" d="100"/>
          <a:sy n="87" d="100"/>
        </p:scale>
        <p:origin x="1266" y="-20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22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60190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22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9963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22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566547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22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3326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22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106167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22/11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81575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22/11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94399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22/11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54272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22/11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50957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22/11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91061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215B4-6E7F-4C5A-9DE7-36F2E676AF73}" type="datetimeFigureOut">
              <a:rPr lang="fr-FR" smtClean="0"/>
              <a:t>22/11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11550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C215B4-6E7F-4C5A-9DE7-36F2E676AF73}" type="datetimeFigureOut">
              <a:rPr lang="fr-FR" smtClean="0"/>
              <a:t>22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C98089-1728-4630-9F7E-C58CA86198E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62034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 flipH="1">
            <a:off x="366735" y="7844091"/>
            <a:ext cx="565411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: Evaluation of different barley cultivars for their resistance against net blotch disease by detached leaves assay under HN and LN. A: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Values of necrosis size are indicated in mm ± SD under HN  and LN . Stars indicate significant difference between LN and HN (Student’s test,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=30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p &lt; 0.05). Data are from three independent experiments.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eres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ioassay on detached leaves at 10 days post-infection.</a:t>
            </a:r>
          </a:p>
          <a:p>
            <a:pPr algn="just"/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ZoneTexte 7"/>
          <p:cNvSpPr txBox="1"/>
          <p:nvPr/>
        </p:nvSpPr>
        <p:spPr>
          <a:xfrm>
            <a:off x="548576" y="1116510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Imag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5079" y="4363269"/>
            <a:ext cx="4966278" cy="3170232"/>
          </a:xfrm>
          <a:prstGeom prst="rect">
            <a:avLst/>
          </a:prstGeom>
        </p:spPr>
      </p:pic>
      <p:sp>
        <p:nvSpPr>
          <p:cNvPr id="11" name="ZoneTexte 10"/>
          <p:cNvSpPr txBox="1"/>
          <p:nvPr/>
        </p:nvSpPr>
        <p:spPr>
          <a:xfrm>
            <a:off x="548576" y="4403881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46540" y="991502"/>
            <a:ext cx="4624817" cy="30832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07419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37</TotalTime>
  <Words>82</Words>
  <Application>Microsoft Office PowerPoint</Application>
  <PresentationFormat>Format A4 (210 x 297 mm)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IN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ia Dellagi</dc:creator>
  <cp:lastModifiedBy>Alia Dellagi</cp:lastModifiedBy>
  <cp:revision>28</cp:revision>
  <cp:lastPrinted>2021-09-15T09:10:34Z</cp:lastPrinted>
  <dcterms:created xsi:type="dcterms:W3CDTF">2021-04-15T18:38:08Z</dcterms:created>
  <dcterms:modified xsi:type="dcterms:W3CDTF">2021-11-22T16:40:53Z</dcterms:modified>
</cp:coreProperties>
</file>